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6492875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0042" autoAdjust="0"/>
    <p:restoredTop sz="94660"/>
  </p:normalViewPr>
  <p:slideViewPr>
    <p:cSldViewPr snapToGrid="0">
      <p:cViewPr varScale="1">
        <p:scale>
          <a:sx n="80" d="100"/>
          <a:sy n="80" d="100"/>
        </p:scale>
        <p:origin x="313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02EFE9-E17E-48A4-BD8A-CA79ACF7271C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43000"/>
            <a:ext cx="2190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0229D6-103D-4C95-91C8-A567FA2A8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0895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1496484"/>
            <a:ext cx="5518944" cy="3183467"/>
          </a:xfrm>
        </p:spPr>
        <p:txBody>
          <a:bodyPr anchor="b"/>
          <a:lstStyle>
            <a:lvl1pPr algn="ctr"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1610" y="4802717"/>
            <a:ext cx="4869656" cy="2207683"/>
          </a:xfrm>
        </p:spPr>
        <p:txBody>
          <a:bodyPr/>
          <a:lstStyle>
            <a:lvl1pPr marL="0" indent="0" algn="ctr">
              <a:buNone/>
              <a:defRPr sz="1704"/>
            </a:lvl1pPr>
            <a:lvl2pPr marL="324658" indent="0" algn="ctr">
              <a:buNone/>
              <a:defRPr sz="1420"/>
            </a:lvl2pPr>
            <a:lvl3pPr marL="649315" indent="0" algn="ctr">
              <a:buNone/>
              <a:defRPr sz="1278"/>
            </a:lvl3pPr>
            <a:lvl4pPr marL="973973" indent="0" algn="ctr">
              <a:buNone/>
              <a:defRPr sz="1136"/>
            </a:lvl4pPr>
            <a:lvl5pPr marL="1298631" indent="0" algn="ctr">
              <a:buNone/>
              <a:defRPr sz="1136"/>
            </a:lvl5pPr>
            <a:lvl6pPr marL="1623289" indent="0" algn="ctr">
              <a:buNone/>
              <a:defRPr sz="1136"/>
            </a:lvl6pPr>
            <a:lvl7pPr marL="1947946" indent="0" algn="ctr">
              <a:buNone/>
              <a:defRPr sz="1136"/>
            </a:lvl7pPr>
            <a:lvl8pPr marL="2272604" indent="0" algn="ctr">
              <a:buNone/>
              <a:defRPr sz="1136"/>
            </a:lvl8pPr>
            <a:lvl9pPr marL="2597262" indent="0" algn="ctr">
              <a:buNone/>
              <a:defRPr sz="113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400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847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6464" y="486834"/>
            <a:ext cx="140002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6385" y="486834"/>
            <a:ext cx="4118918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155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462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3004" y="2279653"/>
            <a:ext cx="5600105" cy="3803649"/>
          </a:xfrm>
        </p:spPr>
        <p:txBody>
          <a:bodyPr anchor="b"/>
          <a:lstStyle>
            <a:lvl1pPr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3004" y="6119286"/>
            <a:ext cx="5600105" cy="2000249"/>
          </a:xfrm>
        </p:spPr>
        <p:txBody>
          <a:bodyPr/>
          <a:lstStyle>
            <a:lvl1pPr marL="0" indent="0">
              <a:buNone/>
              <a:defRPr sz="1704">
                <a:solidFill>
                  <a:schemeClr val="tx1">
                    <a:tint val="82000"/>
                  </a:schemeClr>
                </a:solidFill>
              </a:defRPr>
            </a:lvl1pPr>
            <a:lvl2pPr marL="324658" indent="0">
              <a:buNone/>
              <a:defRPr sz="1420">
                <a:solidFill>
                  <a:schemeClr val="tx1">
                    <a:tint val="82000"/>
                  </a:schemeClr>
                </a:solidFill>
              </a:defRPr>
            </a:lvl2pPr>
            <a:lvl3pPr marL="649315" indent="0">
              <a:buNone/>
              <a:defRPr sz="1278">
                <a:solidFill>
                  <a:schemeClr val="tx1">
                    <a:tint val="82000"/>
                  </a:schemeClr>
                </a:solidFill>
              </a:defRPr>
            </a:lvl3pPr>
            <a:lvl4pPr marL="973973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4pPr>
            <a:lvl5pPr marL="1298631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5pPr>
            <a:lvl6pPr marL="1623289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6pPr>
            <a:lvl7pPr marL="1947946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7pPr>
            <a:lvl8pPr marL="2272604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8pPr>
            <a:lvl9pPr marL="2597262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104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6385" y="2434167"/>
            <a:ext cx="2759472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7018" y="2434167"/>
            <a:ext cx="2759472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765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86836"/>
            <a:ext cx="560010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232" y="2241551"/>
            <a:ext cx="2746790" cy="1098549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7232" y="3340100"/>
            <a:ext cx="2746790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7018" y="2241551"/>
            <a:ext cx="2760318" cy="1098549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7018" y="3340100"/>
            <a:ext cx="276031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638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30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942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609600"/>
            <a:ext cx="2094121" cy="2133600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60318" y="1316569"/>
            <a:ext cx="3287018" cy="6498167"/>
          </a:xfrm>
        </p:spPr>
        <p:txBody>
          <a:bodyPr/>
          <a:lstStyle>
            <a:lvl1pPr>
              <a:defRPr sz="2272"/>
            </a:lvl1pPr>
            <a:lvl2pPr>
              <a:defRPr sz="1988"/>
            </a:lvl2pPr>
            <a:lvl3pPr>
              <a:defRPr sz="1704"/>
            </a:lvl3pPr>
            <a:lvl4pPr>
              <a:defRPr sz="1420"/>
            </a:lvl4pPr>
            <a:lvl5pPr>
              <a:defRPr sz="1420"/>
            </a:lvl5pPr>
            <a:lvl6pPr>
              <a:defRPr sz="1420"/>
            </a:lvl6pPr>
            <a:lvl7pPr>
              <a:defRPr sz="1420"/>
            </a:lvl7pPr>
            <a:lvl8pPr>
              <a:defRPr sz="1420"/>
            </a:lvl8pPr>
            <a:lvl9pPr>
              <a:defRPr sz="14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2743200"/>
            <a:ext cx="2094121" cy="50821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202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609600"/>
            <a:ext cx="2094121" cy="2133600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60318" y="1316569"/>
            <a:ext cx="3287018" cy="6498167"/>
          </a:xfrm>
        </p:spPr>
        <p:txBody>
          <a:bodyPr anchor="t"/>
          <a:lstStyle>
            <a:lvl1pPr marL="0" indent="0">
              <a:buNone/>
              <a:defRPr sz="2272"/>
            </a:lvl1pPr>
            <a:lvl2pPr marL="324658" indent="0">
              <a:buNone/>
              <a:defRPr sz="1988"/>
            </a:lvl2pPr>
            <a:lvl3pPr marL="649315" indent="0">
              <a:buNone/>
              <a:defRPr sz="1704"/>
            </a:lvl3pPr>
            <a:lvl4pPr marL="973973" indent="0">
              <a:buNone/>
              <a:defRPr sz="1420"/>
            </a:lvl4pPr>
            <a:lvl5pPr marL="1298631" indent="0">
              <a:buNone/>
              <a:defRPr sz="1420"/>
            </a:lvl5pPr>
            <a:lvl6pPr marL="1623289" indent="0">
              <a:buNone/>
              <a:defRPr sz="1420"/>
            </a:lvl6pPr>
            <a:lvl7pPr marL="1947946" indent="0">
              <a:buNone/>
              <a:defRPr sz="1420"/>
            </a:lvl7pPr>
            <a:lvl8pPr marL="2272604" indent="0">
              <a:buNone/>
              <a:defRPr sz="1420"/>
            </a:lvl8pPr>
            <a:lvl9pPr marL="2597262" indent="0">
              <a:buNone/>
              <a:defRPr sz="14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2743200"/>
            <a:ext cx="2094121" cy="50821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533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6385" y="486836"/>
            <a:ext cx="560010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85" y="2434167"/>
            <a:ext cx="560010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6385" y="8475136"/>
            <a:ext cx="1460897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50765" y="8475136"/>
            <a:ext cx="219134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5593" y="8475136"/>
            <a:ext cx="1460897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140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9315" rtl="0" eaLnBrk="1" latinLnBrk="0" hangingPunct="1">
        <a:lnSpc>
          <a:spcPct val="90000"/>
        </a:lnSpc>
        <a:spcBef>
          <a:spcPct val="0"/>
        </a:spcBef>
        <a:buNone/>
        <a:defRPr sz="31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329" indent="-162329" algn="l" defTabSz="64931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1pPr>
      <a:lvl2pPr marL="48698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11644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420" kern="1200">
          <a:solidFill>
            <a:schemeClr val="tx1"/>
          </a:solidFill>
          <a:latin typeface="+mn-lt"/>
          <a:ea typeface="+mn-ea"/>
          <a:cs typeface="+mn-cs"/>
        </a:defRPr>
      </a:lvl3pPr>
      <a:lvl4pPr marL="1136302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460960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78561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2110275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434933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759591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1pPr>
      <a:lvl2pPr marL="324658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2pPr>
      <a:lvl3pPr marL="649315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3pPr>
      <a:lvl4pPr marL="973973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298631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623289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1947946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272604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597262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Picture 39">
            <a:extLst>
              <a:ext uri="{FF2B5EF4-FFF2-40B4-BE49-F238E27FC236}">
                <a16:creationId xmlns:a16="http://schemas.microsoft.com/office/drawing/2014/main" id="{F4B51D07-9C19-7D2E-517F-BA9D29316E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3542" y="2210143"/>
            <a:ext cx="1564974" cy="1012874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33D846DE-BE20-66FA-85E8-6969E71B00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4584" y="3267490"/>
            <a:ext cx="1631853" cy="101287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D6C17ED-49A1-34AF-E491-98065AB720A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2548" y="3276053"/>
            <a:ext cx="1631853" cy="101287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9063B24-04BF-AAE0-D981-7B6A0D75690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84294" y="3261835"/>
            <a:ext cx="1631853" cy="101287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438DA0F-1D9A-1381-11B0-5C5AE700FA9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597" t="9401" r="8792"/>
          <a:stretch/>
        </p:blipFill>
        <p:spPr>
          <a:xfrm>
            <a:off x="4525845" y="3261085"/>
            <a:ext cx="1409657" cy="1012874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ED374FEA-AABF-4CE3-9252-014D15126B5C}"/>
              </a:ext>
            </a:extLst>
          </p:cNvPr>
          <p:cNvSpPr txBox="1"/>
          <p:nvPr/>
        </p:nvSpPr>
        <p:spPr>
          <a:xfrm>
            <a:off x="261372" y="2194035"/>
            <a:ext cx="366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DFEE8D7-417A-3A9A-3967-33B064837FE4}"/>
              </a:ext>
            </a:extLst>
          </p:cNvPr>
          <p:cNvSpPr txBox="1"/>
          <p:nvPr/>
        </p:nvSpPr>
        <p:spPr>
          <a:xfrm>
            <a:off x="2754140" y="734972"/>
            <a:ext cx="366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0AB62BC-99BF-A503-A05B-825D819498DB}"/>
              </a:ext>
            </a:extLst>
          </p:cNvPr>
          <p:cNvSpPr txBox="1"/>
          <p:nvPr/>
        </p:nvSpPr>
        <p:spPr>
          <a:xfrm>
            <a:off x="381381" y="666897"/>
            <a:ext cx="366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29A08C7-509B-6633-055A-4E408F005527}"/>
              </a:ext>
            </a:extLst>
          </p:cNvPr>
          <p:cNvSpPr txBox="1"/>
          <p:nvPr/>
        </p:nvSpPr>
        <p:spPr>
          <a:xfrm>
            <a:off x="1682941" y="2216310"/>
            <a:ext cx="366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E972A45-A621-3291-33D7-58AC4B26E674}"/>
              </a:ext>
            </a:extLst>
          </p:cNvPr>
          <p:cNvSpPr txBox="1"/>
          <p:nvPr/>
        </p:nvSpPr>
        <p:spPr>
          <a:xfrm>
            <a:off x="283275" y="3257411"/>
            <a:ext cx="366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G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EEE6185-70BA-E176-DC13-A954B9D7C89D}"/>
              </a:ext>
            </a:extLst>
          </p:cNvPr>
          <p:cNvSpPr txBox="1"/>
          <p:nvPr/>
        </p:nvSpPr>
        <p:spPr>
          <a:xfrm>
            <a:off x="1743351" y="3175656"/>
            <a:ext cx="366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H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6460135-D110-9C96-95EC-A89AA43D5324}"/>
              </a:ext>
            </a:extLst>
          </p:cNvPr>
          <p:cNvSpPr txBox="1"/>
          <p:nvPr/>
        </p:nvSpPr>
        <p:spPr>
          <a:xfrm>
            <a:off x="3140633" y="3181679"/>
            <a:ext cx="366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I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D4106C5-B6EB-9623-3059-8779F21BDFEE}"/>
              </a:ext>
            </a:extLst>
          </p:cNvPr>
          <p:cNvSpPr txBox="1"/>
          <p:nvPr/>
        </p:nvSpPr>
        <p:spPr>
          <a:xfrm>
            <a:off x="4531799" y="3168412"/>
            <a:ext cx="366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J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B07F976-C30F-8516-EE35-9E3F6B519658}"/>
              </a:ext>
            </a:extLst>
          </p:cNvPr>
          <p:cNvSpPr txBox="1"/>
          <p:nvPr/>
        </p:nvSpPr>
        <p:spPr>
          <a:xfrm>
            <a:off x="1089899" y="3400949"/>
            <a:ext cx="529992" cy="191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46" dirty="0">
                <a:latin typeface="Arial" panose="020B0604020202020204" pitchFamily="34" charset="0"/>
                <a:cs typeface="Arial" panose="020B0604020202020204" pitchFamily="34" charset="0"/>
              </a:rPr>
              <a:t>r=-0.019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B322B60-E5AD-A691-6D73-BAE9EF75385C}"/>
              </a:ext>
            </a:extLst>
          </p:cNvPr>
          <p:cNvSpPr txBox="1"/>
          <p:nvPr/>
        </p:nvSpPr>
        <p:spPr>
          <a:xfrm>
            <a:off x="2543368" y="3398996"/>
            <a:ext cx="529992" cy="191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46" dirty="0">
                <a:latin typeface="Arial" panose="020B0604020202020204" pitchFamily="34" charset="0"/>
                <a:cs typeface="Arial" panose="020B0604020202020204" pitchFamily="34" charset="0"/>
              </a:rPr>
              <a:t>r=-0.00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3509D0A-766A-4FC8-A3D0-805E3115AC70}"/>
              </a:ext>
            </a:extLst>
          </p:cNvPr>
          <p:cNvSpPr txBox="1"/>
          <p:nvPr/>
        </p:nvSpPr>
        <p:spPr>
          <a:xfrm>
            <a:off x="3946094" y="3401455"/>
            <a:ext cx="529992" cy="191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46" dirty="0">
                <a:latin typeface="Arial" panose="020B0604020202020204" pitchFamily="34" charset="0"/>
                <a:cs typeface="Arial" panose="020B0604020202020204" pitchFamily="34" charset="0"/>
              </a:rPr>
              <a:t>r=-0.00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3997B12-812F-CB42-9BC0-6B5407D955B4}"/>
              </a:ext>
            </a:extLst>
          </p:cNvPr>
          <p:cNvSpPr txBox="1"/>
          <p:nvPr/>
        </p:nvSpPr>
        <p:spPr>
          <a:xfrm>
            <a:off x="5426268" y="3491329"/>
            <a:ext cx="529992" cy="191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46" dirty="0">
                <a:latin typeface="Arial" panose="020B0604020202020204" pitchFamily="34" charset="0"/>
                <a:cs typeface="Arial" panose="020B0604020202020204" pitchFamily="34" charset="0"/>
              </a:rPr>
              <a:t>r=-0.3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F27FB01-330D-D7D7-C952-61DAE5E6AD5E}"/>
              </a:ext>
            </a:extLst>
          </p:cNvPr>
          <p:cNvSpPr txBox="1"/>
          <p:nvPr/>
        </p:nvSpPr>
        <p:spPr>
          <a:xfrm>
            <a:off x="1083620" y="2408029"/>
            <a:ext cx="529992" cy="191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46" dirty="0">
                <a:latin typeface="Arial" panose="020B0604020202020204" pitchFamily="34" charset="0"/>
                <a:cs typeface="Arial" panose="020B0604020202020204" pitchFamily="34" charset="0"/>
              </a:rPr>
              <a:t>r=-0.27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501F025-9E8F-C8B9-6EEF-54555E20EB3C}"/>
              </a:ext>
            </a:extLst>
          </p:cNvPr>
          <p:cNvSpPr txBox="1"/>
          <p:nvPr/>
        </p:nvSpPr>
        <p:spPr>
          <a:xfrm>
            <a:off x="2232809" y="2360262"/>
            <a:ext cx="529992" cy="191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46" dirty="0">
                <a:latin typeface="Arial" panose="020B0604020202020204" pitchFamily="34" charset="0"/>
                <a:cs typeface="Arial" panose="020B0604020202020204" pitchFamily="34" charset="0"/>
              </a:rPr>
              <a:t>r=-0.3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B8524B6-4F4D-C643-1AA6-697911741C98}"/>
              </a:ext>
            </a:extLst>
          </p:cNvPr>
          <p:cNvSpPr txBox="1"/>
          <p:nvPr/>
        </p:nvSpPr>
        <p:spPr>
          <a:xfrm>
            <a:off x="3815465" y="2413206"/>
            <a:ext cx="529992" cy="191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46" dirty="0">
                <a:latin typeface="Arial" panose="020B0604020202020204" pitchFamily="34" charset="0"/>
                <a:cs typeface="Arial" panose="020B0604020202020204" pitchFamily="34" charset="0"/>
              </a:rPr>
              <a:t>r=-0.18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AE011D2-7ED1-491E-409F-B215B70AC7CC}"/>
              </a:ext>
            </a:extLst>
          </p:cNvPr>
          <p:cNvSpPr txBox="1"/>
          <p:nvPr/>
        </p:nvSpPr>
        <p:spPr>
          <a:xfrm>
            <a:off x="5354217" y="2408029"/>
            <a:ext cx="529992" cy="191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46" dirty="0">
                <a:latin typeface="Arial" panose="020B0604020202020204" pitchFamily="34" charset="0"/>
                <a:cs typeface="Arial" panose="020B0604020202020204" pitchFamily="34" charset="0"/>
              </a:rPr>
              <a:t>r=-0.15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FB742EF-4812-60A4-0F3F-C3F554EB5E36}"/>
              </a:ext>
            </a:extLst>
          </p:cNvPr>
          <p:cNvSpPr txBox="1"/>
          <p:nvPr/>
        </p:nvSpPr>
        <p:spPr>
          <a:xfrm>
            <a:off x="238114" y="77814"/>
            <a:ext cx="2952772" cy="196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8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BF560BB-639D-2084-71E4-FCB62CE782E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3285" y="4341111"/>
            <a:ext cx="1178272" cy="157559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40B49A3-A6A5-F3EA-37E0-365AEFDC03A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56726" y="4288927"/>
            <a:ext cx="1170116" cy="1619115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1D8A577B-1A94-3523-87CA-B7EFE52D059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8689" y="2258055"/>
            <a:ext cx="1667482" cy="1012874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64877FFD-76B7-DF27-4730-0A75A9C9A2D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006224" y="2214256"/>
            <a:ext cx="1631853" cy="1012874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4CC51711-47FB-F543-AEF2-B857F80FBD1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14746" y="2201875"/>
            <a:ext cx="1631853" cy="101287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0899D6C-5A95-6B4B-C6EE-16CD89A83360}"/>
              </a:ext>
            </a:extLst>
          </p:cNvPr>
          <p:cNvSpPr txBox="1"/>
          <p:nvPr/>
        </p:nvSpPr>
        <p:spPr>
          <a:xfrm>
            <a:off x="289576" y="4418036"/>
            <a:ext cx="366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K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71712DB-7A3D-BAAE-DE42-AFD5C351D61F}"/>
              </a:ext>
            </a:extLst>
          </p:cNvPr>
          <p:cNvSpPr txBox="1"/>
          <p:nvPr/>
        </p:nvSpPr>
        <p:spPr>
          <a:xfrm>
            <a:off x="1453048" y="4379293"/>
            <a:ext cx="366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L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F8F6F68-B059-621A-3620-FBE485E683A6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b="30614"/>
          <a:stretch/>
        </p:blipFill>
        <p:spPr>
          <a:xfrm>
            <a:off x="2923949" y="623733"/>
            <a:ext cx="1302738" cy="146327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3A97636-AD1F-59EF-B4A7-FB45D4E9AEF0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b="30439"/>
          <a:stretch/>
        </p:blipFill>
        <p:spPr>
          <a:xfrm>
            <a:off x="596679" y="735946"/>
            <a:ext cx="1187722" cy="1337463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38C72374-A99F-B43F-69F3-5B32D21048C4}"/>
              </a:ext>
            </a:extLst>
          </p:cNvPr>
          <p:cNvSpPr txBox="1"/>
          <p:nvPr/>
        </p:nvSpPr>
        <p:spPr>
          <a:xfrm>
            <a:off x="3727534" y="726566"/>
            <a:ext cx="1659232" cy="20005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9999 CAR 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EF943AB-7C3F-5AF2-754B-2BE710CE89C8}"/>
              </a:ext>
            </a:extLst>
          </p:cNvPr>
          <p:cNvSpPr txBox="1"/>
          <p:nvPr/>
        </p:nvSpPr>
        <p:spPr>
          <a:xfrm>
            <a:off x="3738010" y="826663"/>
            <a:ext cx="1476152" cy="20005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solidFill>
                  <a:srgbClr val="99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CAR 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CD64956-A44B-016E-4164-43D33164A1C4}"/>
              </a:ext>
            </a:extLst>
          </p:cNvPr>
          <p:cNvSpPr txBox="1"/>
          <p:nvPr/>
        </p:nvSpPr>
        <p:spPr>
          <a:xfrm>
            <a:off x="1205658" y="792079"/>
            <a:ext cx="1659232" cy="20005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9999 CAR T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E00DBA1-CFE6-4ABD-1CCA-E49EC0AEA800}"/>
              </a:ext>
            </a:extLst>
          </p:cNvPr>
          <p:cNvSpPr txBox="1"/>
          <p:nvPr/>
        </p:nvSpPr>
        <p:spPr>
          <a:xfrm>
            <a:off x="1216134" y="892176"/>
            <a:ext cx="1476152" cy="20005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solidFill>
                  <a:srgbClr val="99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CAR T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61E32C5-A4F7-D6B1-5328-317293BF11B6}"/>
              </a:ext>
            </a:extLst>
          </p:cNvPr>
          <p:cNvSpPr txBox="1"/>
          <p:nvPr/>
        </p:nvSpPr>
        <p:spPr>
          <a:xfrm>
            <a:off x="3113985" y="2264402"/>
            <a:ext cx="366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2312BC7-4251-9EC4-3887-5ECBA1BFCAEE}"/>
              </a:ext>
            </a:extLst>
          </p:cNvPr>
          <p:cNvSpPr txBox="1"/>
          <p:nvPr/>
        </p:nvSpPr>
        <p:spPr>
          <a:xfrm>
            <a:off x="4529172" y="2254584"/>
            <a:ext cx="366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F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77C81FE-DAD3-6278-267B-A476A4892C11}"/>
              </a:ext>
            </a:extLst>
          </p:cNvPr>
          <p:cNvSpPr txBox="1"/>
          <p:nvPr/>
        </p:nvSpPr>
        <p:spPr>
          <a:xfrm>
            <a:off x="79294" y="6146020"/>
            <a:ext cx="6334286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Analysis and validation of </a:t>
            </a:r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RNA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. A.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umber of GBM cells found 24 hours after CAR T/non-CAR T cell intratumoral infusion. N=4 mice per group.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umber of human T cells found 24 hours after CAR T/non-CAR T cell intratumoral infusion. N=4 mice per group.  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Validation of the most upregulated genes in GBM in response to CAR T treatment using CGGA database (human mRNA expression) showed significant correlation between genes related to CD4+ Th1 including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.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IL12R (N=1011 glioma patients ; R=0.27);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.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IFNGR (N= 1018 glioma patients; R=0.31);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US" sz="1000" b="1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TNF (N= 66 glioma patients ; R=0.18);</a:t>
            </a:r>
            <a:r>
              <a:rPr lang="en-US" sz="1000" b="1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F.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IL15 (N=1010 glioma patients ; R=0.51) and PLAAT4 (second highest upregulated gene).  There was no correlation between CD8+ genes related to cytotoxicity including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G.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GZMB (N= 649 glioma patients; R=0.019);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.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GZMA (N= 651 glioma patients; R=0.002);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.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PRF1 (N= 646 glioma patients; R=0.001);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J.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LAMP1 (N=651 glioma patients; R=-0.30) and CTSS (highest upregulated gene). Showing that human GBM cells activate the same subset of genes in response to T cell activation (CD4+-Th1 T cell activation). 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K. </a:t>
            </a:r>
            <a:r>
              <a:rPr lang="en-US" sz="1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TSS 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RNA fold change in low grade gliomas vs. </a:t>
            </a:r>
            <a:r>
              <a:rPr lang="en-US" sz="1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igh grade gliomas showing an increase in higher grade tumors. </a:t>
            </a:r>
            <a:r>
              <a:rPr lang="en-US" sz="1000" b="1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. </a:t>
            </a:r>
            <a:r>
              <a:rPr lang="en-US" sz="1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LAAT4 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RNA fold change in low grade gliomas vs. </a:t>
            </a:r>
            <a:r>
              <a:rPr lang="en-US" sz="1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igh grade gliomas showing an increase in higher grade tumors. </a:t>
            </a:r>
            <a:b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</a:b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8394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95</TotalTime>
  <Words>357</Words>
  <Application>Microsoft Office PowerPoint</Application>
  <PresentationFormat>Custom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Ulloa Navas, Maria J., Ph.D., M.S.</dc:creator>
  <cp:lastModifiedBy>Ulloa Navas, Maria J., Ph.D., M.S.</cp:lastModifiedBy>
  <cp:revision>64</cp:revision>
  <dcterms:created xsi:type="dcterms:W3CDTF">2024-09-02T16:12:58Z</dcterms:created>
  <dcterms:modified xsi:type="dcterms:W3CDTF">2024-11-22T20:07:42Z</dcterms:modified>
</cp:coreProperties>
</file>